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ct" ContentType="image/x-pict"/>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715B85C-87A7-4587-9649-4D6EF8B2D3B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63F3B57-34D7-406F-8024-A8FE2ACCD8B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813DE72-1571-4250-A3AB-2E2216423A0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448ABD7-90D1-4302-87C6-906CA1B5C31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5F4C56-0C57-49A1-A3F3-36343778B6F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8858936-FBF5-4987-94A2-3EC7B0D6A72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43E2F40-7D3D-4F25-AE3B-55DB99B7E37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5208F70-C6D7-4CDD-B4B1-65E24D7DA4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8A654FA-B57D-49A1-A415-85222CAC4D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8C7B005-59E3-484E-99E2-81AA4F4493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9B04063-D63D-4E05-974D-CCB8E93AE17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A451A8-3C91-4808-B249-BD65B314EA3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82EFCB-A811-42FB-A9D9-35D5E9038E1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ct"/><Relationship Id="rId2"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825480" y="1401840"/>
            <a:ext cx="7193160" cy="334800"/>
          </a:xfrm>
          <a:prstGeom prst="rect">
            <a:avLst/>
          </a:prstGeom>
          <a:no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 name=""/>
          <p:cNvSpPr/>
          <p:nvPr/>
        </p:nvSpPr>
        <p:spPr>
          <a:xfrm>
            <a:off x="744480" y="5334120"/>
            <a:ext cx="733284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An average core expression profile was calculated for each of the 12 tumour subtypes. The Pearson correlation of every tumour sample with each of the 12 core expression profiles was determined. For each sample, the correlation with the more representative of the 12 core expression profiles is shown as color-coded columns. The order of tumour samples is identical to the hierarchical clustering order as depicted in Figure 1.</a:t>
            </a:r>
            <a:endParaRPr b="0" lang="en-US" sz="1200" spc="-1" strike="noStrike">
              <a:solidFill>
                <a:srgbClr val="000000"/>
              </a:solidFill>
              <a:latin typeface="Arial"/>
            </a:endParaRPr>
          </a:p>
        </p:txBody>
      </p:sp>
      <p:sp>
        <p:nvSpPr>
          <p:cNvPr id="43" name=""/>
          <p:cNvSpPr/>
          <p:nvPr/>
        </p:nvSpPr>
        <p:spPr>
          <a:xfrm>
            <a:off x="920880" y="623880"/>
            <a:ext cx="7232400" cy="495720"/>
          </a:xfrm>
          <a:prstGeom prst="rect">
            <a:avLst/>
          </a:prstGeom>
          <a:noFill/>
          <a:ln w="0">
            <a:noFill/>
          </a:ln>
        </p:spPr>
        <p:style>
          <a:lnRef idx="0"/>
          <a:fillRef idx="0"/>
          <a:effectRef idx="0"/>
          <a:fontRef idx="minor"/>
        </p:style>
        <p:txBody>
          <a:bodyPr lIns="90000" rIns="90000" tIns="46800" bIns="46800" anchor="t">
            <a:spAutoFit/>
          </a:bodyPr>
          <a:p>
            <a:pPr>
              <a:lnSpc>
                <a:spcPct val="12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S1 - Correlation of individual tumour samples to the more representative core expression-based subtype profile.</a:t>
            </a:r>
            <a:endParaRPr b="0" lang="en-US" sz="1100" spc="-1" strike="noStrike">
              <a:solidFill>
                <a:srgbClr val="000000"/>
              </a:solidFill>
              <a:latin typeface="Arial"/>
            </a:endParaRPr>
          </a:p>
        </p:txBody>
      </p:sp>
      <p:sp>
        <p:nvSpPr>
          <p:cNvPr id="44" name=""/>
          <p:cNvSpPr/>
          <p:nvPr/>
        </p:nvSpPr>
        <p:spPr>
          <a:xfrm>
            <a:off x="4039200" y="4762440"/>
            <a:ext cx="1317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Tumour samples</a:t>
            </a:r>
            <a:endParaRPr b="0" lang="en-US" sz="1200" spc="-1" strike="noStrike">
              <a:solidFill>
                <a:srgbClr val="000000"/>
              </a:solidFill>
              <a:latin typeface="Arial"/>
            </a:endParaRPr>
          </a:p>
        </p:txBody>
      </p:sp>
      <p:pic>
        <p:nvPicPr>
          <p:cNvPr id="45" name="" descr=""/>
          <p:cNvPicPr/>
          <p:nvPr/>
        </p:nvPicPr>
        <p:blipFill>
          <a:blip r:embed="rId1"/>
          <a:stretch/>
        </p:blipFill>
        <p:spPr>
          <a:xfrm>
            <a:off x="838080" y="1447920"/>
            <a:ext cx="7239240" cy="3352680"/>
          </a:xfrm>
          <a:prstGeom prst="rect">
            <a:avLst/>
          </a:prstGeom>
          <a:ln w="0">
            <a:noFill/>
          </a:ln>
        </p:spPr>
      </p:pic>
      <p:sp>
        <p:nvSpPr>
          <p:cNvPr id="46" name=""/>
          <p:cNvSpPr/>
          <p:nvPr/>
        </p:nvSpPr>
        <p:spPr>
          <a:xfrm rot="16200000">
            <a:off x="-13320" y="2918880"/>
            <a:ext cx="1506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Pearson correlatio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9-07T08:46:05Z</dcterms:created>
  <dc:creator>Maia Boulfroy</dc:creator>
  <dc:description/>
  <dc:language>en-US</dc:language>
  <cp:lastModifiedBy>Utilisateur de la version d'évaluation de Office 2004</cp:lastModifiedBy>
  <cp:lastPrinted>2006-12-14T13:47:18Z</cp:lastPrinted>
  <dcterms:modified xsi:type="dcterms:W3CDTF">2007-02-20T10:04:17Z</dcterms:modified>
  <cp:revision>7</cp:revision>
  <dc:subject/>
  <dc:title>Diapositive 1</dc:title>
</cp:coreProperties>
</file>